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303" r:id="rId2"/>
  </p:sldIdLst>
  <p:sldSz cx="6858000" cy="9144000" type="letter"/>
  <p:notesSz cx="7315200" cy="9601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872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audel, Dinesh" initials="PD" lastIdx="1" clrIdx="0">
    <p:extLst>
      <p:ext uri="{19B8F6BF-5375-455C-9EA6-DF929625EA0E}">
        <p15:presenceInfo xmlns:p15="http://schemas.microsoft.com/office/powerpoint/2012/main" userId="S-1-5-21-1645522239-1202660629-725345543-243944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DD71"/>
    <a:srgbClr val="0000FF"/>
    <a:srgbClr val="663300"/>
    <a:srgbClr val="9B0000"/>
    <a:srgbClr val="6464FF"/>
    <a:srgbClr val="65DFF7"/>
    <a:srgbClr val="FFCCCC"/>
    <a:srgbClr val="FF0000"/>
    <a:srgbClr val="FF6600"/>
    <a:srgbClr val="FF33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165" autoAdjust="0"/>
    <p:restoredTop sz="96370" autoAdjust="0"/>
  </p:normalViewPr>
  <p:slideViewPr>
    <p:cSldViewPr snapToGrid="0">
      <p:cViewPr varScale="1">
        <p:scale>
          <a:sx n="60" d="100"/>
          <a:sy n="60" d="100"/>
        </p:scale>
        <p:origin x="686" y="38"/>
      </p:cViewPr>
      <p:guideLst>
        <p:guide orient="horz" pos="4872"/>
        <p:guide pos="312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paudeld\Desktop\thesis%20writing\1-full%20compilled_.June28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spPr>
            <a:ln w="952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dPt>
            <c:idx val="7"/>
            <c:marker>
              <c:symbol val="none"/>
            </c:marker>
            <c:bubble3D val="0"/>
            <c:extLst>
              <c:ext xmlns:c16="http://schemas.microsoft.com/office/drawing/2014/chart" uri="{C3380CC4-5D6E-409C-BE32-E72D297353CC}">
                <c16:uniqueId val="{00000001-4FFE-4858-8EAE-B76A5585DC4F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Sheet1!$I$104:$I$112</c:f>
                <c:numCache>
                  <c:formatCode>General</c:formatCode>
                  <c:ptCount val="9"/>
                  <c:pt idx="0">
                    <c:v>3.6517149273914168E-2</c:v>
                  </c:pt>
                  <c:pt idx="1">
                    <c:v>5.4059275524588009E-2</c:v>
                  </c:pt>
                  <c:pt idx="2">
                    <c:v>0.1695405021344554</c:v>
                  </c:pt>
                  <c:pt idx="3">
                    <c:v>0.10221359755616341</c:v>
                  </c:pt>
                  <c:pt idx="4">
                    <c:v>0.10145049811233062</c:v>
                  </c:pt>
                  <c:pt idx="5">
                    <c:v>0.41977154825492136</c:v>
                  </c:pt>
                  <c:pt idx="6">
                    <c:v>0.1682192597016168</c:v>
                  </c:pt>
                  <c:pt idx="7">
                    <c:v>0.1319495188831446</c:v>
                  </c:pt>
                  <c:pt idx="8">
                    <c:v>0.13359180312339528</c:v>
                  </c:pt>
                </c:numCache>
              </c:numRef>
            </c:plus>
            <c:minus>
              <c:numRef>
                <c:f>Sheet1!$I$104:$I$112</c:f>
                <c:numCache>
                  <c:formatCode>General</c:formatCode>
                  <c:ptCount val="9"/>
                  <c:pt idx="0">
                    <c:v>3.6517149273914168E-2</c:v>
                  </c:pt>
                  <c:pt idx="1">
                    <c:v>5.4059275524588009E-2</c:v>
                  </c:pt>
                  <c:pt idx="2">
                    <c:v>0.1695405021344554</c:v>
                  </c:pt>
                  <c:pt idx="3">
                    <c:v>0.10221359755616341</c:v>
                  </c:pt>
                  <c:pt idx="4">
                    <c:v>0.10145049811233062</c:v>
                  </c:pt>
                  <c:pt idx="5">
                    <c:v>0.41977154825492136</c:v>
                  </c:pt>
                  <c:pt idx="6">
                    <c:v>0.1682192597016168</c:v>
                  </c:pt>
                  <c:pt idx="7">
                    <c:v>0.1319495188831446</c:v>
                  </c:pt>
                  <c:pt idx="8">
                    <c:v>0.1335918031233952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B$104:$B$112</c:f>
              <c:numCache>
                <c:formatCode>General</c:formatCode>
                <c:ptCount val="9"/>
                <c:pt idx="0">
                  <c:v>0.05</c:v>
                </c:pt>
                <c:pt idx="1">
                  <c:v>0.1</c:v>
                </c:pt>
                <c:pt idx="2">
                  <c:v>0.2</c:v>
                </c:pt>
                <c:pt idx="3">
                  <c:v>0.4</c:v>
                </c:pt>
                <c:pt idx="4">
                  <c:v>0.8</c:v>
                </c:pt>
                <c:pt idx="5">
                  <c:v>1</c:v>
                </c:pt>
                <c:pt idx="6">
                  <c:v>2</c:v>
                </c:pt>
                <c:pt idx="7">
                  <c:v>4</c:v>
                </c:pt>
                <c:pt idx="8">
                  <c:v>5</c:v>
                </c:pt>
              </c:numCache>
            </c:numRef>
          </c:xVal>
          <c:yVal>
            <c:numRef>
              <c:f>Sheet1!$H$104:$H$112</c:f>
              <c:numCache>
                <c:formatCode>0.00</c:formatCode>
                <c:ptCount val="9"/>
                <c:pt idx="0">
                  <c:v>0.23704146666666664</c:v>
                </c:pt>
                <c:pt idx="1">
                  <c:v>0.40540876666666664</c:v>
                </c:pt>
                <c:pt idx="2">
                  <c:v>0.80472226666666669</c:v>
                </c:pt>
                <c:pt idx="3">
                  <c:v>1.1453945666666665</c:v>
                </c:pt>
                <c:pt idx="4">
                  <c:v>2.2617965999999998</c:v>
                </c:pt>
                <c:pt idx="5">
                  <c:v>2.5626973333333334</c:v>
                </c:pt>
                <c:pt idx="6">
                  <c:v>3.8718127999999998</c:v>
                </c:pt>
                <c:pt idx="7">
                  <c:v>4.9498549333333335</c:v>
                </c:pt>
                <c:pt idx="8">
                  <c:v>6.9452623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4FFE-4858-8EAE-B76A5585DC4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74376120"/>
        <c:axId val="474376776"/>
      </c:scatterChart>
      <c:valAx>
        <c:axId val="4743761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74376776"/>
        <c:crosses val="autoZero"/>
        <c:crossBetween val="midCat"/>
      </c:valAx>
      <c:valAx>
        <c:axId val="474376776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noFill/>
          <a:ln w="31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74376120"/>
        <c:crosses val="autoZero"/>
        <c:crossBetween val="midCat"/>
      </c:valAx>
      <c:spPr>
        <a:noFill/>
        <a:ln w="635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8"/>
          </a:xfrm>
          <a:prstGeom prst="rect">
            <a:avLst/>
          </a:prstGeom>
        </p:spPr>
        <p:txBody>
          <a:bodyPr vert="horz" lIns="97617" tIns="48808" rIns="97617" bIns="48808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8" y="0"/>
            <a:ext cx="3169920" cy="481728"/>
          </a:xfrm>
          <a:prstGeom prst="rect">
            <a:avLst/>
          </a:prstGeom>
        </p:spPr>
        <p:txBody>
          <a:bodyPr vert="horz" lIns="97617" tIns="48808" rIns="97617" bIns="48808" rtlCol="0"/>
          <a:lstStyle>
            <a:lvl1pPr algn="r">
              <a:defRPr sz="1300"/>
            </a:lvl1pPr>
          </a:lstStyle>
          <a:p>
            <a:fld id="{CEF8B743-0503-4B98-A872-9431C8A0E75D}" type="datetimeFigureOut">
              <a:rPr lang="en-US" smtClean="0"/>
              <a:t>3/22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43163" y="1200150"/>
            <a:ext cx="242887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7617" tIns="48808" rIns="97617" bIns="48808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620577"/>
            <a:ext cx="5852160" cy="3780472"/>
          </a:xfrm>
          <a:prstGeom prst="rect">
            <a:avLst/>
          </a:prstGeom>
        </p:spPr>
        <p:txBody>
          <a:bodyPr vert="horz" lIns="97617" tIns="48808" rIns="97617" bIns="48808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5"/>
            <a:ext cx="3169920" cy="481727"/>
          </a:xfrm>
          <a:prstGeom prst="rect">
            <a:avLst/>
          </a:prstGeom>
        </p:spPr>
        <p:txBody>
          <a:bodyPr vert="horz" lIns="97617" tIns="48808" rIns="97617" bIns="48808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8" y="9119475"/>
            <a:ext cx="3169920" cy="481727"/>
          </a:xfrm>
          <a:prstGeom prst="rect">
            <a:avLst/>
          </a:prstGeom>
        </p:spPr>
        <p:txBody>
          <a:bodyPr vert="horz" lIns="97617" tIns="48808" rIns="97617" bIns="48808" rtlCol="0" anchor="b"/>
          <a:lstStyle>
            <a:lvl1pPr algn="r">
              <a:defRPr sz="1300"/>
            </a:lvl1pPr>
          </a:lstStyle>
          <a:p>
            <a:fld id="{7516F5E5-C8A8-4CDF-91E5-1606C998B1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99695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516F5E5-C8A8-4CDF-91E5-1606C998B13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02996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D3283-6F4C-4DFF-AB3F-7D6A64FE024E}" type="datetimeFigureOut">
              <a:rPr lang="en-US" smtClean="0"/>
              <a:t>3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D291E-A061-4BF5-AD39-0A3114D0CD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34264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D3283-6F4C-4DFF-AB3F-7D6A64FE024E}" type="datetimeFigureOut">
              <a:rPr lang="en-US" smtClean="0"/>
              <a:t>3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D291E-A061-4BF5-AD39-0A3114D0CD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11804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D3283-6F4C-4DFF-AB3F-7D6A64FE024E}" type="datetimeFigureOut">
              <a:rPr lang="en-US" smtClean="0"/>
              <a:t>3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D291E-A061-4BF5-AD39-0A3114D0CD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18317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D3283-6F4C-4DFF-AB3F-7D6A64FE024E}" type="datetimeFigureOut">
              <a:rPr lang="en-US" smtClean="0"/>
              <a:t>3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D291E-A061-4BF5-AD39-0A3114D0CD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64726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D3283-6F4C-4DFF-AB3F-7D6A64FE024E}" type="datetimeFigureOut">
              <a:rPr lang="en-US" smtClean="0"/>
              <a:t>3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D291E-A061-4BF5-AD39-0A3114D0CD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99513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D3283-6F4C-4DFF-AB3F-7D6A64FE024E}" type="datetimeFigureOut">
              <a:rPr lang="en-US" smtClean="0"/>
              <a:t>3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D291E-A061-4BF5-AD39-0A3114D0CD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85543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D3283-6F4C-4DFF-AB3F-7D6A64FE024E}" type="datetimeFigureOut">
              <a:rPr lang="en-US" smtClean="0"/>
              <a:t>3/2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D291E-A061-4BF5-AD39-0A3114D0CD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89628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D3283-6F4C-4DFF-AB3F-7D6A64FE024E}" type="datetimeFigureOut">
              <a:rPr lang="en-US" smtClean="0"/>
              <a:t>3/2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D291E-A061-4BF5-AD39-0A3114D0CD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5189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D3283-6F4C-4DFF-AB3F-7D6A64FE024E}" type="datetimeFigureOut">
              <a:rPr lang="en-US" smtClean="0"/>
              <a:t>3/2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D291E-A061-4BF5-AD39-0A3114D0CD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04052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D3283-6F4C-4DFF-AB3F-7D6A64FE024E}" type="datetimeFigureOut">
              <a:rPr lang="en-US" smtClean="0"/>
              <a:t>3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D291E-A061-4BF5-AD39-0A3114D0CD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7163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D3283-6F4C-4DFF-AB3F-7D6A64FE024E}" type="datetimeFigureOut">
              <a:rPr lang="en-US" smtClean="0"/>
              <a:t>3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D291E-A061-4BF5-AD39-0A3114D0CD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91712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AD3283-6F4C-4DFF-AB3F-7D6A64FE024E}" type="datetimeFigureOut">
              <a:rPr lang="en-US" smtClean="0"/>
              <a:t>3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BD291E-A061-4BF5-AD39-0A3114D0CD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04590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26682" y="5779061"/>
            <a:ext cx="31101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ncentration of VRV transcripts (</a:t>
            </a:r>
            <a:r>
              <a:rPr lang="en-U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ole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/ 50 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l reaction) 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 rot="16200000">
            <a:off x="888861" y="4714976"/>
            <a:ext cx="149934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luc activity ( X 10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graphicFrame>
        <p:nvGraphicFramePr>
          <p:cNvPr id="92" name="Chart 9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66536350"/>
              </p:ext>
            </p:extLst>
          </p:nvPr>
        </p:nvGraphicFramePr>
        <p:xfrm>
          <a:off x="1725692" y="4080719"/>
          <a:ext cx="3227308" cy="17425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Rectangle 3"/>
          <p:cNvSpPr/>
          <p:nvPr/>
        </p:nvSpPr>
        <p:spPr>
          <a:xfrm>
            <a:off x="812800" y="1329744"/>
            <a:ext cx="5245100" cy="113909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CA" sz="1000" b="1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S3 Fig. </a:t>
            </a:r>
            <a:r>
              <a:rPr lang="en-CA" sz="1000" b="1" i="1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In vitro</a:t>
            </a:r>
            <a:r>
              <a:rPr lang="en-CA" sz="1000" b="1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 translation rate of the VRV transcript at various transcript concentrations. </a:t>
            </a:r>
            <a:r>
              <a:rPr lang="en-CA" sz="10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VRV transcripts were added to </a:t>
            </a:r>
            <a:r>
              <a:rPr lang="en-CA" sz="1000" i="1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in vitro</a:t>
            </a:r>
            <a:r>
              <a:rPr lang="en-CA" sz="10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 translation reactions at the concentrations of 0.05, 0.1, 0.2, 0.4, 0.8, 1, 2, 4 or 5 </a:t>
            </a:r>
            <a:r>
              <a:rPr lang="en-CA" sz="1000" dirty="0" err="1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picomoles</a:t>
            </a:r>
            <a:r>
              <a:rPr lang="en-CA" sz="10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 per 50 </a:t>
            </a:r>
            <a:r>
              <a:rPr lang="en-CA" sz="1000" dirty="0" err="1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μl</a:t>
            </a:r>
            <a:r>
              <a:rPr lang="en-CA" sz="10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 WGE and the resulting luminescence were measured. Experiments were repeated twice, each with three technical repeats, with similar results. A representative result is shown. Error bars represent the standard deviation of the three technical repeats.</a:t>
            </a:r>
            <a:endParaRPr lang="en-US" sz="1000" dirty="0">
              <a:latin typeface="Arial" panose="020B0604020202020204" pitchFamily="34" charset="0"/>
              <a:ea typeface="Cambria" panose="020405030504060302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883962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1960</TotalTime>
  <Words>110</Words>
  <Application>Microsoft Office PowerPoint</Application>
  <PresentationFormat>Letter Paper (8.5x11 in)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ambri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del, Dinesh</dc:creator>
  <cp:lastModifiedBy>Sanfaçon, Hélène</cp:lastModifiedBy>
  <cp:revision>687</cp:revision>
  <cp:lastPrinted>2021-01-14T23:34:08Z</cp:lastPrinted>
  <dcterms:created xsi:type="dcterms:W3CDTF">2019-03-12T16:33:50Z</dcterms:created>
  <dcterms:modified xsi:type="dcterms:W3CDTF">2021-03-22T20:31:49Z</dcterms:modified>
</cp:coreProperties>
</file>